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7896790-F592-47BF-8958-CEFBA5861F96}" v="1" dt="2024-07-13T22:27:59.8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44" d="100"/>
          <a:sy n="144" d="100"/>
        </p:scale>
        <p:origin x="94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n, Hening" userId="1ad506b0-93f1-4f52-90fb-3dd1b2ccac5e" providerId="ADAL" clId="{87896790-F592-47BF-8958-CEFBA5861F96}"/>
    <pc:docChg chg="modSld">
      <pc:chgData name="Ren, Hening" userId="1ad506b0-93f1-4f52-90fb-3dd1b2ccac5e" providerId="ADAL" clId="{87896790-F592-47BF-8958-CEFBA5861F96}" dt="2024-07-13T22:28:02.710" v="1" actId="20577"/>
      <pc:docMkLst>
        <pc:docMk/>
      </pc:docMkLst>
      <pc:sldChg chg="modSp mod">
        <pc:chgData name="Ren, Hening" userId="1ad506b0-93f1-4f52-90fb-3dd1b2ccac5e" providerId="ADAL" clId="{87896790-F592-47BF-8958-CEFBA5861F96}" dt="2024-07-13T22:28:02.710" v="1" actId="20577"/>
        <pc:sldMkLst>
          <pc:docMk/>
          <pc:sldMk cId="2507873023" sldId="257"/>
        </pc:sldMkLst>
        <pc:spChg chg="mod">
          <ac:chgData name="Ren, Hening" userId="1ad506b0-93f1-4f52-90fb-3dd1b2ccac5e" providerId="ADAL" clId="{87896790-F592-47BF-8958-CEFBA5861F96}" dt="2024-07-13T22:28:02.710" v="1" actId="20577"/>
          <ac:spMkLst>
            <pc:docMk/>
            <pc:sldMk cId="2507873023" sldId="257"/>
            <ac:spMk id="6" creationId="{544400F0-B62D-CA94-5E6A-F82F9E77DCBC}"/>
          </ac:spMkLst>
        </pc:spChg>
      </pc:sldChg>
    </pc:docChg>
  </pc:docChgLst>
  <pc:docChgLst>
    <pc:chgData name="Ren, Hening" userId="1ad506b0-93f1-4f52-90fb-3dd1b2ccac5e" providerId="ADAL" clId="{CEFAF1CB-C6C3-4C4F-8FB1-F1AA5A6A3FA9}"/>
    <pc:docChg chg="custSel modSld">
      <pc:chgData name="Ren, Hening" userId="1ad506b0-93f1-4f52-90fb-3dd1b2ccac5e" providerId="ADAL" clId="{CEFAF1CB-C6C3-4C4F-8FB1-F1AA5A6A3FA9}" dt="2024-07-10T16:19:37.622" v="49" actId="478"/>
      <pc:docMkLst>
        <pc:docMk/>
      </pc:docMkLst>
      <pc:sldChg chg="addSp delSp modSp mod">
        <pc:chgData name="Ren, Hening" userId="1ad506b0-93f1-4f52-90fb-3dd1b2ccac5e" providerId="ADAL" clId="{CEFAF1CB-C6C3-4C4F-8FB1-F1AA5A6A3FA9}" dt="2024-07-10T16:19:37.622" v="49" actId="478"/>
        <pc:sldMkLst>
          <pc:docMk/>
          <pc:sldMk cId="2507873023" sldId="257"/>
        </pc:sldMkLst>
        <pc:spChg chg="del mod">
          <ac:chgData name="Ren, Hening" userId="1ad506b0-93f1-4f52-90fb-3dd1b2ccac5e" providerId="ADAL" clId="{CEFAF1CB-C6C3-4C4F-8FB1-F1AA5A6A3FA9}" dt="2024-07-10T16:19:37.622" v="49" actId="478"/>
          <ac:spMkLst>
            <pc:docMk/>
            <pc:sldMk cId="2507873023" sldId="257"/>
            <ac:spMk id="4" creationId="{249FA9DA-E4A9-F95E-1DD9-3E3969711761}"/>
          </ac:spMkLst>
        </pc:spChg>
        <pc:spChg chg="add mod">
          <ac:chgData name="Ren, Hening" userId="1ad506b0-93f1-4f52-90fb-3dd1b2ccac5e" providerId="ADAL" clId="{CEFAF1CB-C6C3-4C4F-8FB1-F1AA5A6A3FA9}" dt="2024-07-10T16:19:35.133" v="48" actId="1076"/>
          <ac:spMkLst>
            <pc:docMk/>
            <pc:sldMk cId="2507873023" sldId="257"/>
            <ac:spMk id="6" creationId="{544400F0-B62D-CA94-5E6A-F82F9E77DCBC}"/>
          </ac:spMkLst>
        </pc:spChg>
        <pc:graphicFrameChg chg="add del mod">
          <ac:chgData name="Ren, Hening" userId="1ad506b0-93f1-4f52-90fb-3dd1b2ccac5e" providerId="ADAL" clId="{CEFAF1CB-C6C3-4C4F-8FB1-F1AA5A6A3FA9}" dt="2024-07-10T16:11:25.440" v="39" actId="478"/>
          <ac:graphicFrameMkLst>
            <pc:docMk/>
            <pc:sldMk cId="2507873023" sldId="257"/>
            <ac:graphicFrameMk id="2" creationId="{74DF36B9-47C8-0198-A83D-9339D2E7A9A5}"/>
          </ac:graphicFrameMkLst>
        </pc:graphicFrameChg>
        <pc:graphicFrameChg chg="mod">
          <ac:chgData name="Ren, Hening" userId="1ad506b0-93f1-4f52-90fb-3dd1b2ccac5e" providerId="ADAL" clId="{CEFAF1CB-C6C3-4C4F-8FB1-F1AA5A6A3FA9}" dt="2024-07-10T16:11:40.973" v="43"/>
          <ac:graphicFrameMkLst>
            <pc:docMk/>
            <pc:sldMk cId="2507873023" sldId="257"/>
            <ac:graphicFrameMk id="5" creationId="{74C78ECF-6755-83C8-D988-ED117D48B02F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ren\Desktop\827_199%20treatment\041219b.Minito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Erlotinib /827</a:t>
            </a:r>
          </a:p>
        </c:rich>
      </c:tx>
      <c:layout>
        <c:manualLayout>
          <c:xMode val="edge"/>
          <c:yMode val="edge"/>
          <c:x val="0.35039526175687108"/>
          <c:y val="1.20101869081397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304780123732227"/>
          <c:y val="7.3890704777311911E-2"/>
          <c:w val="0.79431322785373226"/>
          <c:h val="0.78523989008630002"/>
        </c:manualLayout>
      </c:layout>
      <c:lineChart>
        <c:grouping val="standard"/>
        <c:varyColors val="0"/>
        <c:ser>
          <c:idx val="0"/>
          <c:order val="0"/>
          <c:tx>
            <c:strRef>
              <c:f>Erlotinib!$B$2</c:f>
              <c:strCache>
                <c:ptCount val="1"/>
                <c:pt idx="0">
                  <c:v>#3L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numRef>
              <c:f>Erlotinib!$A$3:$A$24</c:f>
              <c:numCache>
                <c:formatCode>General</c:formatCode>
                <c:ptCount val="2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</c:numCache>
            </c:numRef>
          </c:cat>
          <c:val>
            <c:numRef>
              <c:f>Erlotinib!$B$3:$B$24</c:f>
              <c:numCache>
                <c:formatCode>General</c:formatCode>
                <c:ptCount val="22"/>
                <c:pt idx="0">
                  <c:v>419.83</c:v>
                </c:pt>
                <c:pt idx="1">
                  <c:v>248.83</c:v>
                </c:pt>
                <c:pt idx="2">
                  <c:v>156.28</c:v>
                </c:pt>
                <c:pt idx="3">
                  <c:v>123.87</c:v>
                </c:pt>
                <c:pt idx="4">
                  <c:v>107.39</c:v>
                </c:pt>
                <c:pt idx="5">
                  <c:v>92.7</c:v>
                </c:pt>
                <c:pt idx="6">
                  <c:v>81.12</c:v>
                </c:pt>
                <c:pt idx="7">
                  <c:v>79.33</c:v>
                </c:pt>
                <c:pt idx="8">
                  <c:v>80</c:v>
                </c:pt>
                <c:pt idx="9">
                  <c:v>75.63</c:v>
                </c:pt>
                <c:pt idx="10">
                  <c:v>72.900000000000006</c:v>
                </c:pt>
                <c:pt idx="11">
                  <c:v>70.27</c:v>
                </c:pt>
                <c:pt idx="12">
                  <c:v>72.58</c:v>
                </c:pt>
                <c:pt idx="13">
                  <c:v>89.89</c:v>
                </c:pt>
                <c:pt idx="14">
                  <c:v>122.3</c:v>
                </c:pt>
                <c:pt idx="15">
                  <c:v>171.06</c:v>
                </c:pt>
                <c:pt idx="16">
                  <c:v>245.48</c:v>
                </c:pt>
                <c:pt idx="17">
                  <c:v>363.38</c:v>
                </c:pt>
                <c:pt idx="18">
                  <c:v>427.73</c:v>
                </c:pt>
                <c:pt idx="19">
                  <c:v>463.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5A1-4A66-9126-FE9FBC823C4E}"/>
            </c:ext>
          </c:extLst>
        </c:ser>
        <c:ser>
          <c:idx val="1"/>
          <c:order val="1"/>
          <c:tx>
            <c:strRef>
              <c:f>Erlotinib!$C$2</c:f>
              <c:strCache>
                <c:ptCount val="1"/>
                <c:pt idx="0">
                  <c:v>#6L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Erlotinib!$A$3:$A$24</c:f>
              <c:numCache>
                <c:formatCode>General</c:formatCode>
                <c:ptCount val="2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</c:numCache>
            </c:numRef>
          </c:cat>
          <c:val>
            <c:numRef>
              <c:f>Erlotinib!$C$3:$C$24</c:f>
              <c:numCache>
                <c:formatCode>General</c:formatCode>
                <c:ptCount val="22"/>
                <c:pt idx="0">
                  <c:v>303.26</c:v>
                </c:pt>
                <c:pt idx="1">
                  <c:v>219.96</c:v>
                </c:pt>
                <c:pt idx="2">
                  <c:v>134.56</c:v>
                </c:pt>
                <c:pt idx="3">
                  <c:v>96.91</c:v>
                </c:pt>
                <c:pt idx="4">
                  <c:v>54.68</c:v>
                </c:pt>
                <c:pt idx="5">
                  <c:v>44.11</c:v>
                </c:pt>
                <c:pt idx="6">
                  <c:v>34.99</c:v>
                </c:pt>
                <c:pt idx="7">
                  <c:v>28</c:v>
                </c:pt>
                <c:pt idx="8">
                  <c:v>22.53</c:v>
                </c:pt>
                <c:pt idx="9">
                  <c:v>33.21</c:v>
                </c:pt>
                <c:pt idx="10">
                  <c:v>49.39</c:v>
                </c:pt>
                <c:pt idx="11">
                  <c:v>62.78</c:v>
                </c:pt>
                <c:pt idx="12">
                  <c:v>105.46</c:v>
                </c:pt>
                <c:pt idx="13">
                  <c:v>166.7</c:v>
                </c:pt>
                <c:pt idx="14">
                  <c:v>234.41</c:v>
                </c:pt>
                <c:pt idx="15">
                  <c:v>330.67</c:v>
                </c:pt>
                <c:pt idx="16">
                  <c:v>406.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5A1-4A66-9126-FE9FBC823C4E}"/>
            </c:ext>
          </c:extLst>
        </c:ser>
        <c:ser>
          <c:idx val="2"/>
          <c:order val="2"/>
          <c:tx>
            <c:strRef>
              <c:f>Erlotinib!$D$2</c:f>
              <c:strCache>
                <c:ptCount val="1"/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Erlotinib!$A$3:$A$24</c:f>
              <c:numCache>
                <c:formatCode>General</c:formatCode>
                <c:ptCount val="2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</c:numCache>
            </c:numRef>
          </c:cat>
          <c:val>
            <c:numRef>
              <c:f>Erlotinib!$D$3:$D$24</c:f>
              <c:numCache>
                <c:formatCode>General</c:formatCode>
                <c:ptCount val="22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5A1-4A66-9126-FE9FBC823C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2135152"/>
        <c:axId val="342132976"/>
      </c:lineChart>
      <c:catAx>
        <c:axId val="3421351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Days after first dosing</a:t>
                </a:r>
              </a:p>
            </c:rich>
          </c:tx>
          <c:layout>
            <c:manualLayout>
              <c:xMode val="edge"/>
              <c:yMode val="edge"/>
              <c:x val="0.29986142780185193"/>
              <c:y val="0.927718333803258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in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2132976"/>
        <c:crosses val="autoZero"/>
        <c:auto val="1"/>
        <c:lblAlgn val="ctr"/>
        <c:lblOffset val="100"/>
        <c:noMultiLvlLbl val="0"/>
      </c:catAx>
      <c:valAx>
        <c:axId val="342132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Tumor Volume (mm</a:t>
                </a:r>
                <a:r>
                  <a:rPr lang="en-US" sz="1200" b="1" baseline="30000" dirty="0">
                    <a:solidFill>
                      <a:schemeClr val="tx1"/>
                    </a:solidFill>
                  </a:rPr>
                  <a:t>3</a:t>
                </a:r>
                <a:r>
                  <a:rPr lang="en-US" sz="1200" b="1" dirty="0">
                    <a:solidFill>
                      <a:schemeClr val="tx1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7.8277358713412983E-3"/>
              <c:y val="0.29005704681167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2135152"/>
        <c:crosses val="autoZero"/>
        <c:crossBetween val="between"/>
        <c:minorUnit val="2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rgbClr val="002060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609B23-8428-F715-8D55-6B7EB39BEE2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111914-225F-AE5C-2D2E-9C3E3A3873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B6A565-7FFD-23EE-F507-CEDAC38A9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04D907-B554-CA52-98A9-8FB7C455C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66B964-B9E8-5DE4-47EF-E86563814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052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0657BE-60D2-D7E3-47AC-1BDDD60357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5201CF-9944-6949-54DE-1C59372172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773E02-4E1F-1470-6AC7-990C8A841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5D8AAA-0B4D-23A9-1E9B-834A32A343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DF1760-F780-702A-6228-B2E5942D3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926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2702CD-A808-21BD-027C-D74662968C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B7C7E7-FD7E-8903-B5CE-8039B246D1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6D1170-1016-BD1B-CD44-C029FE1ED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D501BC-CFD1-9E97-A532-871B11F99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811762-C7A8-F371-DB79-3B0B8718F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98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BB5D84-D7BB-E2B6-B7AD-D657EA2E34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4E8429-536E-A419-BEA8-A3A8F777C8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BFDEEB-D513-D47A-980D-5DF1958C6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6F3D73-E0C2-7BD2-C030-58C6D02D1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924741-7A3E-4564-B350-E345FB9A9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4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EC24CD-40EB-A417-3408-9EE2D621F9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C933C5-E872-FBB1-5C25-2EF2712DB8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8B6A03-EB8E-9E90-08A5-5CF2DFF87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C2F026-6FA6-C86B-122B-3B9F93BCE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5992A7-1914-76E7-AF8E-753E17ECF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904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854DA0-3FDE-11BD-507C-065CC9D29E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B20299-925B-81C7-CDF2-0330E7686C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F9BA19-D859-4C5C-EB1B-F2C4D83D0A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DB4589-6527-B404-82F0-2F67C5E35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E5015F-BE85-3658-6871-E41D3C8F0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9E12F8-1B59-629A-CA7D-B2A4E30FE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280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03342-B1F5-ECF8-17B4-9E8DB5E38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BC2167-0D8A-B09A-1927-A5064E4A1D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066562-382A-56E0-2ECB-20DDBF1C4B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1954C8-1A35-DFEB-1078-212FF77B61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06F806-8EAF-AB7F-C491-6877EC188D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DCB2DE-5402-5A1A-D31E-3F9A3C7A38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9AA8F3-CD16-E742-6663-F700E238A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F4A4CFE-09C7-81B9-0C5F-51815024B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564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CA1FE-DEC1-8711-3254-8D34D27683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A3B2D4-48BB-CD71-A825-DB9040561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2A684A-96E5-3940-71C9-D2D07E06A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AE215F-38BC-69A9-961E-9579423F9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707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3A783E3-43C5-138A-87A6-56887445FF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CEA40FB-58BD-F4A0-8A61-714242ED7B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0C8EE62-CE3B-8A9B-2194-AF9B9A800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688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3AAA02-EA39-CB1C-6F2D-4EA6B7143E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411B7A-4DB0-0331-EAB2-AA78C84A1B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3E42C7-6F61-DC09-5CE5-259BE67FB4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288F64-B155-6C53-44A4-B45F09F2B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B36FFF-4BCC-C616-0993-1C4641DAC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DC328E-B8BC-230F-86B8-32D1A5214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086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53B205-4B4C-3750-0E7B-D8152971B9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942869-F1CC-3459-B3C1-74B4B9E28E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EDEC1F-286D-CB1E-A0BB-2671152E90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C9C132-BF93-9B90-004F-C14708812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BAA96C-E45D-1084-23E9-4D97A5625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D8E23A-1DD1-DCE0-CA40-8C64D4C1A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147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F51E79B-FE8A-4DF2-F172-43894276A0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F89453-A9BA-08C8-ADAA-BCBB9DD42C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1A0060-D60F-55D0-0134-0F3E0AADCB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7BD3D5-245C-44B2-9281-6B1ED6D2A425}" type="datetimeFigureOut">
              <a:rPr lang="en-US" smtClean="0"/>
              <a:t>7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78E9E2-9698-DD13-DC1E-CFB8800904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0D7AA8-46FD-AAC7-6E45-511BE76EC9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AC5E43-FA6A-4DA3-B014-881FE8ED3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560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74C78ECF-6755-83C8-D988-ED117D48B0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4359267"/>
              </p:ext>
            </p:extLst>
          </p:nvPr>
        </p:nvGraphicFramePr>
        <p:xfrm>
          <a:off x="4620235" y="1122072"/>
          <a:ext cx="2951530" cy="31317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44400F0-B62D-CA94-5E6A-F82F9E77DCBC}"/>
              </a:ext>
            </a:extLst>
          </p:cNvPr>
          <p:cNvSpPr txBox="1"/>
          <p:nvPr/>
        </p:nvSpPr>
        <p:spPr>
          <a:xfrm>
            <a:off x="3472873" y="4466350"/>
            <a:ext cx="6096000" cy="12695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 Figure 1. Effect of erlotinib on </a:t>
            </a:r>
            <a:r>
              <a:rPr lang="en-US" sz="1200" b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cc827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xenograft tumor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cc827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ell (1 x 10</a:t>
            </a:r>
            <a:r>
              <a:rPr lang="en-US" sz="12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6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was subcutaneously injected on the flank of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SG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ouse to produce xenograft tumor. Mouse bearing established tumor was given erlotinib hydrochloride (LC Laboratory, E4007)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aily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t 100 mg/kg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.o.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umor volumes were measured every three days. The spider plot shows the tumor volume change over the treatment course.  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7873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4</TotalTime>
  <Words>89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n, Hening</dc:creator>
  <cp:lastModifiedBy>Ren, Hening</cp:lastModifiedBy>
  <cp:revision>1</cp:revision>
  <dcterms:created xsi:type="dcterms:W3CDTF">2024-07-03T02:13:08Z</dcterms:created>
  <dcterms:modified xsi:type="dcterms:W3CDTF">2024-07-13T22:28:10Z</dcterms:modified>
</cp:coreProperties>
</file>